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</p:sldIdLst>
  <p:sldSz cx="6858000" cy="12192000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349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lomka, Marek" userId="b5697613-81d3-4318-a926-46b10f876ab5" providerId="ADAL" clId="{184DCB77-4CCD-498A-8ACD-DC0A84C93578}"/>
    <pc:docChg chg="modSld">
      <pc:chgData name="Slomka, Marek" userId="b5697613-81d3-4318-a926-46b10f876ab5" providerId="ADAL" clId="{184DCB77-4CCD-498A-8ACD-DC0A84C93578}" dt="2023-04-17T12:05:01.522" v="3" actId="20577"/>
      <pc:docMkLst>
        <pc:docMk/>
      </pc:docMkLst>
      <pc:sldChg chg="modSp mod">
        <pc:chgData name="Slomka, Marek" userId="b5697613-81d3-4318-a926-46b10f876ab5" providerId="ADAL" clId="{184DCB77-4CCD-498A-8ACD-DC0A84C93578}" dt="2023-04-17T12:05:01.522" v="3" actId="20577"/>
        <pc:sldMkLst>
          <pc:docMk/>
          <pc:sldMk cId="645741837" sldId="260"/>
        </pc:sldMkLst>
        <pc:spChg chg="mod">
          <ac:chgData name="Slomka, Marek" userId="b5697613-81d3-4318-a926-46b10f876ab5" providerId="ADAL" clId="{184DCB77-4CCD-498A-8ACD-DC0A84C93578}" dt="2023-04-17T12:05:01.522" v="3" actId="20577"/>
          <ac:spMkLst>
            <pc:docMk/>
            <pc:sldMk cId="645741837" sldId="260"/>
            <ac:spMk id="2" creationId="{BA7083DE-FB01-45CB-98F8-0EA6873C4422}"/>
          </ac:spMkLst>
        </pc:spChg>
      </pc:sldChg>
    </pc:docChg>
  </pc:docChgLst>
  <pc:docChgLst>
    <pc:chgData name="Marek Slomka" userId="b5697613-81d3-4318-a926-46b10f876ab5" providerId="ADAL" clId="{83D69AC0-D920-4639-8EFA-EF1EC972066F}"/>
    <pc:docChg chg="modSld">
      <pc:chgData name="Marek Slomka" userId="b5697613-81d3-4318-a926-46b10f876ab5" providerId="ADAL" clId="{83D69AC0-D920-4639-8EFA-EF1EC972066F}" dt="2023-05-16T17:50:21.683" v="209" actId="20577"/>
      <pc:docMkLst>
        <pc:docMk/>
      </pc:docMkLst>
      <pc:sldChg chg="modSp mod">
        <pc:chgData name="Marek Slomka" userId="b5697613-81d3-4318-a926-46b10f876ab5" providerId="ADAL" clId="{83D69AC0-D920-4639-8EFA-EF1EC972066F}" dt="2023-05-16T17:50:21.683" v="209" actId="20577"/>
        <pc:sldMkLst>
          <pc:docMk/>
          <pc:sldMk cId="645741837" sldId="260"/>
        </pc:sldMkLst>
        <pc:spChg chg="mod">
          <ac:chgData name="Marek Slomka" userId="b5697613-81d3-4318-a926-46b10f876ab5" providerId="ADAL" clId="{83D69AC0-D920-4639-8EFA-EF1EC972066F}" dt="2023-05-16T17:50:21.683" v="209" actId="20577"/>
          <ac:spMkLst>
            <pc:docMk/>
            <pc:sldMk cId="645741837" sldId="260"/>
            <ac:spMk id="2" creationId="{BA7083DE-FB01-45CB-98F8-0EA6873C4422}"/>
          </ac:spMkLst>
        </pc:spChg>
      </pc:sldChg>
    </pc:docChg>
  </pc:docChgLst>
  <pc:docChgLst>
    <pc:chgData name="Slomka, Marek" userId="b5697613-81d3-4318-a926-46b10f876ab5" providerId="ADAL" clId="{E7A4349F-69FD-44A3-8730-23E29491D52F}"/>
    <pc:docChg chg="modSld">
      <pc:chgData name="Slomka, Marek" userId="b5697613-81d3-4318-a926-46b10f876ab5" providerId="ADAL" clId="{E7A4349F-69FD-44A3-8730-23E29491D52F}" dt="2022-09-20T11:41:20.048" v="35" actId="20577"/>
      <pc:docMkLst>
        <pc:docMk/>
      </pc:docMkLst>
      <pc:sldChg chg="modSp mod">
        <pc:chgData name="Slomka, Marek" userId="b5697613-81d3-4318-a926-46b10f876ab5" providerId="ADAL" clId="{E7A4349F-69FD-44A3-8730-23E29491D52F}" dt="2022-09-20T11:41:20.048" v="35" actId="20577"/>
        <pc:sldMkLst>
          <pc:docMk/>
          <pc:sldMk cId="645741837" sldId="260"/>
        </pc:sldMkLst>
        <pc:spChg chg="mod">
          <ac:chgData name="Slomka, Marek" userId="b5697613-81d3-4318-a926-46b10f876ab5" providerId="ADAL" clId="{E7A4349F-69FD-44A3-8730-23E29491D52F}" dt="2022-09-20T11:41:20.048" v="35" actId="20577"/>
          <ac:spMkLst>
            <pc:docMk/>
            <pc:sldMk cId="645741837" sldId="260"/>
            <ac:spMk id="2" creationId="{BA7083DE-FB01-45CB-98F8-0EA6873C4422}"/>
          </ac:spMkLst>
        </pc:spChg>
      </pc:sldChg>
    </pc:docChg>
  </pc:docChgLst>
  <pc:docChgLst>
    <pc:chgData name="Slomka, Marek" userId="b5697613-81d3-4318-a926-46b10f876ab5" providerId="ADAL" clId="{7CD3046B-B155-417F-A4C2-AB4182C07CE4}"/>
    <pc:docChg chg="custSel modSld">
      <pc:chgData name="Slomka, Marek" userId="b5697613-81d3-4318-a926-46b10f876ab5" providerId="ADAL" clId="{7CD3046B-B155-417F-A4C2-AB4182C07CE4}" dt="2022-09-16T13:58:00.325" v="422" actId="20577"/>
      <pc:docMkLst>
        <pc:docMk/>
      </pc:docMkLst>
      <pc:sldChg chg="modSp mod">
        <pc:chgData name="Slomka, Marek" userId="b5697613-81d3-4318-a926-46b10f876ab5" providerId="ADAL" clId="{7CD3046B-B155-417F-A4C2-AB4182C07CE4}" dt="2022-09-16T13:58:00.325" v="422" actId="20577"/>
        <pc:sldMkLst>
          <pc:docMk/>
          <pc:sldMk cId="645741837" sldId="260"/>
        </pc:sldMkLst>
        <pc:spChg chg="mod">
          <ac:chgData name="Slomka, Marek" userId="b5697613-81d3-4318-a926-46b10f876ab5" providerId="ADAL" clId="{7CD3046B-B155-417F-A4C2-AB4182C07CE4}" dt="2022-09-16T13:58:00.325" v="422" actId="20577"/>
          <ac:spMkLst>
            <pc:docMk/>
            <pc:sldMk cId="645741837" sldId="260"/>
            <ac:spMk id="2" creationId="{BA7083DE-FB01-45CB-98F8-0EA6873C442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21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561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468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056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180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9185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372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432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19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926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4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A2A76-11FE-4E60-8BEC-7261569C7CD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1EE43-746B-4E7C-A56C-DEDBF96F5E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834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ECFD7E9-DD52-43D7-B756-7D18422E16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7338259"/>
              </p:ext>
            </p:extLst>
          </p:nvPr>
        </p:nvGraphicFramePr>
        <p:xfrm>
          <a:off x="311150" y="1519238"/>
          <a:ext cx="6235700" cy="915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235390" imgH="9152758" progId="Prism8.Document">
                  <p:embed/>
                </p:oleObj>
              </mc:Choice>
              <mc:Fallback>
                <p:oleObj name="Prism 8" r:id="rId2" imgW="6235390" imgH="9152758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ECFD7E9-DD52-43D7-B756-7D18422E16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1150" y="1519238"/>
                        <a:ext cx="6235700" cy="915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4F30EE4-0375-421E-A288-37D81E3931B8}"/>
              </a:ext>
            </a:extLst>
          </p:cNvPr>
          <p:cNvSpPr txBox="1"/>
          <p:nvPr/>
        </p:nvSpPr>
        <p:spPr>
          <a:xfrm>
            <a:off x="568095" y="1752105"/>
            <a:ext cx="66793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dirty="0"/>
              <a:t>a)</a:t>
            </a:r>
            <a:r>
              <a:rPr lang="en-GB" dirty="0"/>
              <a:t>  </a:t>
            </a:r>
            <a:r>
              <a:rPr lang="en-GB" sz="2000" dirty="0"/>
              <a:t>n=24; 24/24 H5N1 infected, 7/24 APMV-1 infecte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63F29D5-649D-4336-B17E-DBA27A18A404}"/>
              </a:ext>
            </a:extLst>
          </p:cNvPr>
          <p:cNvSpPr txBox="1"/>
          <p:nvPr/>
        </p:nvSpPr>
        <p:spPr>
          <a:xfrm>
            <a:off x="895435" y="6270780"/>
            <a:ext cx="5651415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dirty="0"/>
              <a:t>b) </a:t>
            </a:r>
            <a:r>
              <a:rPr lang="en-GB" dirty="0"/>
              <a:t> </a:t>
            </a:r>
            <a:r>
              <a:rPr lang="en-GB" sz="2000" dirty="0"/>
              <a:t>n=20; 8/20 H5N1 infected, 0/20 APMV-1 infected</a:t>
            </a:r>
          </a:p>
          <a:p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2591511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F6685EE-B8FE-4BD1-AD0B-F94EAB456A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6426899"/>
              </p:ext>
            </p:extLst>
          </p:nvPr>
        </p:nvGraphicFramePr>
        <p:xfrm>
          <a:off x="902368" y="1147720"/>
          <a:ext cx="5065295" cy="9530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9243">
                  <a:extLst>
                    <a:ext uri="{9D8B030D-6E8A-4147-A177-3AD203B41FA5}">
                      <a16:colId xmlns:a16="http://schemas.microsoft.com/office/drawing/2014/main" val="4241316796"/>
                    </a:ext>
                  </a:extLst>
                </a:gridCol>
                <a:gridCol w="704361">
                  <a:extLst>
                    <a:ext uri="{9D8B030D-6E8A-4147-A177-3AD203B41FA5}">
                      <a16:colId xmlns:a16="http://schemas.microsoft.com/office/drawing/2014/main" val="384856939"/>
                    </a:ext>
                  </a:extLst>
                </a:gridCol>
                <a:gridCol w="1022066">
                  <a:extLst>
                    <a:ext uri="{9D8B030D-6E8A-4147-A177-3AD203B41FA5}">
                      <a16:colId xmlns:a16="http://schemas.microsoft.com/office/drawing/2014/main" val="4224642074"/>
                    </a:ext>
                  </a:extLst>
                </a:gridCol>
                <a:gridCol w="803109">
                  <a:extLst>
                    <a:ext uri="{9D8B030D-6E8A-4147-A177-3AD203B41FA5}">
                      <a16:colId xmlns:a16="http://schemas.microsoft.com/office/drawing/2014/main" val="482732675"/>
                    </a:ext>
                  </a:extLst>
                </a:gridCol>
                <a:gridCol w="782455">
                  <a:extLst>
                    <a:ext uri="{9D8B030D-6E8A-4147-A177-3AD203B41FA5}">
                      <a16:colId xmlns:a16="http://schemas.microsoft.com/office/drawing/2014/main" val="1689183754"/>
                    </a:ext>
                  </a:extLst>
                </a:gridCol>
                <a:gridCol w="514698">
                  <a:extLst>
                    <a:ext uri="{9D8B030D-6E8A-4147-A177-3AD203B41FA5}">
                      <a16:colId xmlns:a16="http://schemas.microsoft.com/office/drawing/2014/main" val="3589671173"/>
                    </a:ext>
                  </a:extLst>
                </a:gridCol>
                <a:gridCol w="519363">
                  <a:extLst>
                    <a:ext uri="{9D8B030D-6E8A-4147-A177-3AD203B41FA5}">
                      <a16:colId xmlns:a16="http://schemas.microsoft.com/office/drawing/2014/main" val="3868676186"/>
                    </a:ext>
                  </a:extLst>
                </a:gridCol>
              </a:tblGrid>
              <a:tr h="154718"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200" b="1" u="none" strike="noStrike" dirty="0">
                          <a:effectLst/>
                        </a:rPr>
                        <a:t>Duck #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200" b="1" u="none" strike="noStrike" dirty="0">
                          <a:effectLst/>
                        </a:rPr>
                        <a:t>Swab typ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/>
                </a:tc>
                <a:tc gridSpan="3">
                  <a:txBody>
                    <a:bodyPr/>
                    <a:lstStyle/>
                    <a:p>
                      <a:pPr algn="ctr" fontAlgn="t"/>
                      <a:r>
                        <a:rPr lang="en-GB" sz="1200" b="1" u="none" strike="noStrike">
                          <a:effectLst/>
                        </a:rPr>
                        <a:t>AIV RRT-PCRs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L gene RRT-PCR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7126604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M-gen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H5-H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N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FAM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HEX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020372099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4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657914037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9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746809209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090901578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166141763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7.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325770995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9.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9.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546165353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072024359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788429768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27.8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7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5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029475190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4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3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730138607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7.3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100203075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7.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815315166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6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7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744823925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57013258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445365544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488831474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32.7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33.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35.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2919012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4.1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5.0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7.3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6.6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9830341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1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OP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27.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28.1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0.8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645110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0.7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1.6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4.4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highlight>
                            <a:srgbClr val="FFFF00"/>
                          </a:highlight>
                        </a:rPr>
                        <a:t>36.3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2665623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1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5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3189117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5.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8.4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8.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29.2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0737747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9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5.3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6.2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134642889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7.8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7.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82497898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1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8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9392010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3.0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5.2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6.9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0.7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7077342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OP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3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851078633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626815525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8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7.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293976612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3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881505911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1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977908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5.4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6.3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9.0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3.6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0956462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5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4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002119994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0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0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513343455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1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9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2289653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6.3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0.2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9045417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5.5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150782835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0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353664060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3.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960044435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9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4.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34101372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7.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0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3673816076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9.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1.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368574406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4.7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5.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7.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772692666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3.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4.3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6.4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135935265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3.7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3.8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6.3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1610114536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0.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2.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/>
                </a:tc>
                <a:extLst>
                  <a:ext uri="{0D108BD9-81ED-4DB2-BD59-A6C34878D82A}">
                    <a16:rowId xmlns:a16="http://schemas.microsoft.com/office/drawing/2014/main" val="277684796"/>
                  </a:ext>
                </a:extLst>
              </a:tr>
              <a:tr h="1547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O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6.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6.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28.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4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36.5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3935147"/>
                  </a:ext>
                </a:extLst>
              </a:tr>
              <a:tr h="1547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20.3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19.1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21.8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33.4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36" marR="7736" marT="7736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871513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3F713D1-9216-41D3-AA3C-1B90FD1266B1}"/>
              </a:ext>
            </a:extLst>
          </p:cNvPr>
          <p:cNvSpPr txBox="1"/>
          <p:nvPr/>
        </p:nvSpPr>
        <p:spPr>
          <a:xfrm>
            <a:off x="324852" y="445169"/>
            <a:ext cx="63526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(c)  Tabulation of Ct values from the first epidemiological unit shown graphically in panel (a) </a:t>
            </a:r>
          </a:p>
        </p:txBody>
      </p:sp>
    </p:spTree>
    <p:extLst>
      <p:ext uri="{BB962C8B-B14F-4D97-AF65-F5344CB8AC3E}">
        <p14:creationId xmlns:p14="http://schemas.microsoft.com/office/powerpoint/2010/main" val="2017060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7083DE-FB01-45CB-98F8-0EA6873C4422}"/>
              </a:ext>
            </a:extLst>
          </p:cNvPr>
          <p:cNvSpPr txBox="1"/>
          <p:nvPr/>
        </p:nvSpPr>
        <p:spPr>
          <a:xfrm>
            <a:off x="294774" y="415592"/>
            <a:ext cx="6268451" cy="4784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1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 Investigation of H5N1 HPAIV outbreak in domestic ducks at IP40 by RRT-PCRs and serology, revealing co-infection with APMV-1 in one of the </a:t>
            </a:r>
            <a:r>
              <a:rPr lang="en-GB" sz="11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o sampled epidemiological 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ts. The results for the whole of IP40 (n=44 sampled ducks in total; Suppl. Fig. S5f) have been divided 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 show the Ct value distributions (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P and C shedding)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the (a) first (n=24; 3- and 5-week old ducks) and (b) second (n=20; 7-week-old ducks) epidemiological units. In addition to the Ct values registered by the three AIV RRT-PCRs, Ct values for the OP and C swabs at the first unit are also shown for the L-gene 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T-PCR which specifically detects APMV-1, see Sutton </a:t>
            </a:r>
            <a:r>
              <a:rPr lang="en-GB" sz="11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2019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or technical details of the fluorescence channels and 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Ct 37 positive cut-off value. See Fig 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legend for other details. (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) Tabulation of the three AIV and L-gene RRT-PCR Ct values at the first epidemiological unit to indicate the seven ducks (yellow highlighted) which were co-infected with H5N1 HPAIV and APMV-1. These seven ducks all shed APMV-1 from the C tract, but duck # 24 demonstrated APMV-1 shedding from both OP and C tracts.  Forty sera from both units at IP40 were also tested by serology (HI), with H5 HI seropositive results shown in Suppl. Fig S8 and listed in Suppl. 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2. None of the IP40 duck sera were positive by the APMV-1 (NDV) HI testing, using inactivated chicken/Ireland/Ulster/1967 as the HI antigen (see Methods).  </a:t>
            </a:r>
            <a:r>
              <a:rPr lang="en-GB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645741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2</TotalTime>
  <Words>669</Words>
  <Application>Microsoft Office PowerPoint</Application>
  <PresentationFormat>Widescreen</PresentationFormat>
  <Paragraphs>32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omka, Marek</dc:creator>
  <cp:lastModifiedBy>Marek Slomka</cp:lastModifiedBy>
  <cp:revision>15</cp:revision>
  <cp:lastPrinted>2022-05-19T11:26:51Z</cp:lastPrinted>
  <dcterms:created xsi:type="dcterms:W3CDTF">2022-05-18T17:59:56Z</dcterms:created>
  <dcterms:modified xsi:type="dcterms:W3CDTF">2023-05-16T17:51:47Z</dcterms:modified>
</cp:coreProperties>
</file>